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5" r:id="rId2"/>
    <p:sldId id="264" r:id="rId3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1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2900BD6-6CCD-65B7-0F78-3212C510922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DB4209C6-C59E-EB31-29C3-0FBD7A97E9D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925E1F22-2267-39B0-1472-C576ACDE00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3CEA3D-E152-42A0-BE37-8F2BAF54E86B}" type="datetimeFigureOut">
              <a:rPr lang="es-ES" smtClean="0"/>
              <a:t>12/12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77C8220F-EE1B-0626-E51B-194DAE4EAB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367A800D-58D4-5285-9DE5-6AC5E4F92F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C9336A-2CCA-436B-AAC6-6A19E9006B8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124886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63A19751-F2E2-5416-3FAF-DD665DB995F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5B0C6A6B-0F9D-9EF6-F5B2-CF6EB466C39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B0C65436-471E-24E1-CF31-ADB3A661FF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3CEA3D-E152-42A0-BE37-8F2BAF54E86B}" type="datetimeFigureOut">
              <a:rPr lang="es-ES" smtClean="0"/>
              <a:t>12/12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AEE813C2-D172-4B75-8F0A-9F190BDD02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3472DDAD-323B-7ED3-F026-D5F30B2F3E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C9336A-2CCA-436B-AAC6-6A19E9006B8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947662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5669A4D8-31D1-0083-4A8F-D6A4639E2AA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0E587075-6CB4-D6B7-C4A6-4E6E19962D2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7331FA24-D1EC-BC85-9A4D-3D7BD56EC9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3CEA3D-E152-42A0-BE37-8F2BAF54E86B}" type="datetimeFigureOut">
              <a:rPr lang="es-ES" smtClean="0"/>
              <a:t>12/12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C8DD37D0-67D0-D54E-31CD-6A46CBCF84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062E348F-4055-3192-E3E1-77555EED0C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C9336A-2CCA-436B-AAC6-6A19E9006B8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303867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59E7AC8-B1A3-E295-983F-8774DD30676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7A936A1E-7C40-3148-2596-B48004111C5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4CF9CF61-4E9C-C8DE-C252-ED90EB6133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3CEA3D-E152-42A0-BE37-8F2BAF54E86B}" type="datetimeFigureOut">
              <a:rPr lang="es-ES" smtClean="0"/>
              <a:t>12/12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9476032B-D453-3811-EA78-7C44672F56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27FDBAB1-512F-B915-1498-2E8CF42102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C9336A-2CCA-436B-AAC6-6A19E9006B8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322901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B73147F-06FD-363C-8086-3D4AB26E3F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4FCD0D18-4936-10D9-76D8-C096BF17308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A63BC313-6974-158B-CE72-4994B0D4FE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3CEA3D-E152-42A0-BE37-8F2BAF54E86B}" type="datetimeFigureOut">
              <a:rPr lang="es-ES" smtClean="0"/>
              <a:t>12/12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92CCC8A1-EBC5-FD1D-AF54-515F187505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12D0A720-ECBA-677D-ADFF-CBCBA3E782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C9336A-2CCA-436B-AAC6-6A19E9006B8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725305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5EAA308-95F7-3CD0-BC18-A50417D27D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A32B4299-500F-A7AD-D1A1-6BFF78914DF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D7EBF67C-B18B-49D4-5715-77E35C3C088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89F82C51-E277-BACE-DD43-DAF5A78850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3CEA3D-E152-42A0-BE37-8F2BAF54E86B}" type="datetimeFigureOut">
              <a:rPr lang="es-ES" smtClean="0"/>
              <a:t>12/12/2022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F2866331-A10C-1EDF-B321-D91993F838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CCCE3FD5-B8E9-D08C-01F6-E7EDAC70EE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C9336A-2CCA-436B-AAC6-6A19E9006B8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047778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FB29C16-D5B4-46F8-6CF6-A6629F28864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3BEF08BF-712F-120B-8563-143C891B434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E4A3CD8F-38EB-5B68-DD75-1F0B73B1799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0C848257-55AD-8A7F-2302-0D33D05B5FA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BEC926C1-A285-2704-EB51-56F3ED2CBFA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81F7F6D9-6F2C-0F32-D72C-1AA1BEF845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3CEA3D-E152-42A0-BE37-8F2BAF54E86B}" type="datetimeFigureOut">
              <a:rPr lang="es-ES" smtClean="0"/>
              <a:t>12/12/2022</a:t>
            </a:fld>
            <a:endParaRPr lang="es-ES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7611C4B9-1F6F-76BC-EF5E-433ABC8892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AB39EA14-1529-D9EF-A97D-17A613C3E2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C9336A-2CCA-436B-AAC6-6A19E9006B8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157181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C268E39-9737-C06D-3DA4-6BC7581E19B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F2C79808-A265-ABCD-7B20-93FD00B549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3CEA3D-E152-42A0-BE37-8F2BAF54E86B}" type="datetimeFigureOut">
              <a:rPr lang="es-ES" smtClean="0"/>
              <a:t>12/12/2022</a:t>
            </a:fld>
            <a:endParaRPr lang="es-ES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ECE9ACF3-10B9-13C9-B13A-D047934C53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5E8AC937-7181-B522-B66D-893C85AA74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C9336A-2CCA-436B-AAC6-6A19E9006B8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439141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17B6FF41-61D3-6485-4795-5A91BA8E2F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3CEA3D-E152-42A0-BE37-8F2BAF54E86B}" type="datetimeFigureOut">
              <a:rPr lang="es-ES" smtClean="0"/>
              <a:t>12/12/2022</a:t>
            </a:fld>
            <a:endParaRPr lang="es-ES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B13B58CD-445E-64DB-1E9E-9F8750A3FD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66AB9F2A-D064-E5B4-593F-C597E6C321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C9336A-2CCA-436B-AAC6-6A19E9006B8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420439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CD422D3-EF0F-26AB-920E-F84D869FFA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98BA01F8-32D4-6B76-495D-D2EE817C593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8347562B-7665-73EE-6979-812944FC268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309ADE8A-F8D0-E6A1-2E06-CD38CC8D5B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3CEA3D-E152-42A0-BE37-8F2BAF54E86B}" type="datetimeFigureOut">
              <a:rPr lang="es-ES" smtClean="0"/>
              <a:t>12/12/2022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E2CD4254-D7B2-AE8D-826C-749626869A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0946B752-35A9-94AD-7AC8-100B5F31A4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C9336A-2CCA-436B-AAC6-6A19E9006B8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371751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6EF0736-4AA3-5ADD-6282-1A5928A566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24A03F72-E3D1-5A50-7735-DCC374EC0C0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B26716F4-F9E4-296D-016A-AF9C58D89D7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D62EF159-3771-71A6-6A60-2217B3E95A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3CEA3D-E152-42A0-BE37-8F2BAF54E86B}" type="datetimeFigureOut">
              <a:rPr lang="es-ES" smtClean="0"/>
              <a:t>12/12/2022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9A8A2BEA-B8F6-8A20-C783-D78A1EC7A7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3D17B4E0-BF9E-37B6-012D-4B733CB327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C9336A-2CCA-436B-AAC6-6A19E9006B8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901032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AAB05458-0F40-B8C1-AC4F-5011E1514D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E4F9AA6E-DF79-5003-D1F7-5F5F56A5D1F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A56D06DD-0885-AE33-6C75-A11AD5898EA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3CEA3D-E152-42A0-BE37-8F2BAF54E86B}" type="datetimeFigureOut">
              <a:rPr lang="es-ES" smtClean="0"/>
              <a:t>12/12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F9921066-1D8F-B58A-E850-6E319576151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76D320E2-341D-AB0C-B671-40A6FF55F18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C9336A-2CCA-436B-AAC6-6A19E9006B8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384255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8.emf"/><Relationship Id="rId4" Type="http://schemas.openxmlformats.org/officeDocument/2006/relationships/image" Target="../media/image7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n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28405" y="558558"/>
            <a:ext cx="3708400" cy="2514600"/>
          </a:xfrm>
          <a:prstGeom prst="rect">
            <a:avLst/>
          </a:prstGeom>
        </p:spPr>
      </p:pic>
      <p:pic>
        <p:nvPicPr>
          <p:cNvPr id="5" name="Imagen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490254" y="558558"/>
            <a:ext cx="3708400" cy="2514600"/>
          </a:xfrm>
          <a:prstGeom prst="rect">
            <a:avLst/>
          </a:prstGeom>
        </p:spPr>
      </p:pic>
      <p:pic>
        <p:nvPicPr>
          <p:cNvPr id="6" name="Imagen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583021" y="3578909"/>
            <a:ext cx="3708400" cy="2514600"/>
          </a:xfrm>
          <a:prstGeom prst="rect">
            <a:avLst/>
          </a:prstGeom>
        </p:spPr>
      </p:pic>
      <p:pic>
        <p:nvPicPr>
          <p:cNvPr id="9" name="Imagen 8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628405" y="3578909"/>
            <a:ext cx="3708400" cy="2514600"/>
          </a:xfrm>
          <a:prstGeom prst="rect">
            <a:avLst/>
          </a:prstGeom>
        </p:spPr>
      </p:pic>
      <p:sp>
        <p:nvSpPr>
          <p:cNvPr id="10" name="CuadroTexto 9"/>
          <p:cNvSpPr txBox="1"/>
          <p:nvPr/>
        </p:nvSpPr>
        <p:spPr>
          <a:xfrm>
            <a:off x="3798200" y="3288040"/>
            <a:ext cx="13216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 err="1"/>
              <a:t>Group</a:t>
            </a:r>
            <a:r>
              <a:rPr lang="es-ES" dirty="0"/>
              <a:t> A</a:t>
            </a:r>
          </a:p>
        </p:txBody>
      </p:sp>
      <p:sp>
        <p:nvSpPr>
          <p:cNvPr id="11" name="CuadroTexto 10"/>
          <p:cNvSpPr txBox="1"/>
          <p:nvPr/>
        </p:nvSpPr>
        <p:spPr>
          <a:xfrm>
            <a:off x="8155724" y="3359629"/>
            <a:ext cx="13216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 err="1"/>
              <a:t>Group</a:t>
            </a:r>
            <a:r>
              <a:rPr lang="es-ES" dirty="0"/>
              <a:t> A</a:t>
            </a:r>
          </a:p>
        </p:txBody>
      </p:sp>
      <p:sp>
        <p:nvSpPr>
          <p:cNvPr id="8" name="CuadroTexto 7"/>
          <p:cNvSpPr txBox="1"/>
          <p:nvPr/>
        </p:nvSpPr>
        <p:spPr>
          <a:xfrm>
            <a:off x="2499173" y="270359"/>
            <a:ext cx="5259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A)</a:t>
            </a:r>
          </a:p>
        </p:txBody>
      </p:sp>
      <p:sp>
        <p:nvSpPr>
          <p:cNvPr id="12" name="CuadroTexto 11"/>
          <p:cNvSpPr txBox="1"/>
          <p:nvPr/>
        </p:nvSpPr>
        <p:spPr>
          <a:xfrm>
            <a:off x="2628405" y="3233103"/>
            <a:ext cx="5259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B)</a:t>
            </a:r>
          </a:p>
        </p:txBody>
      </p:sp>
      <p:sp>
        <p:nvSpPr>
          <p:cNvPr id="13" name="CuadroTexto 12"/>
          <p:cNvSpPr txBox="1"/>
          <p:nvPr/>
        </p:nvSpPr>
        <p:spPr>
          <a:xfrm>
            <a:off x="6467753" y="184666"/>
            <a:ext cx="5259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C)</a:t>
            </a:r>
          </a:p>
        </p:txBody>
      </p:sp>
      <p:sp>
        <p:nvSpPr>
          <p:cNvPr id="14" name="CuadroTexto 13"/>
          <p:cNvSpPr txBox="1"/>
          <p:nvPr/>
        </p:nvSpPr>
        <p:spPr>
          <a:xfrm>
            <a:off x="6227256" y="3359629"/>
            <a:ext cx="5259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D)</a:t>
            </a:r>
          </a:p>
        </p:txBody>
      </p:sp>
      <p:sp>
        <p:nvSpPr>
          <p:cNvPr id="15" name="CuadroTexto 14"/>
          <p:cNvSpPr txBox="1"/>
          <p:nvPr/>
        </p:nvSpPr>
        <p:spPr>
          <a:xfrm>
            <a:off x="3798200" y="113077"/>
            <a:ext cx="13216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 err="1"/>
              <a:t>All</a:t>
            </a:r>
            <a:r>
              <a:rPr lang="es-ES" dirty="0"/>
              <a:t> </a:t>
            </a:r>
            <a:r>
              <a:rPr lang="es-ES" dirty="0" err="1"/>
              <a:t>samples</a:t>
            </a:r>
            <a:endParaRPr lang="es-ES" dirty="0"/>
          </a:p>
        </p:txBody>
      </p:sp>
      <p:sp>
        <p:nvSpPr>
          <p:cNvPr id="17" name="CuadroTexto 16"/>
          <p:cNvSpPr txBox="1"/>
          <p:nvPr/>
        </p:nvSpPr>
        <p:spPr>
          <a:xfrm>
            <a:off x="7991691" y="126467"/>
            <a:ext cx="13216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 err="1"/>
              <a:t>All</a:t>
            </a:r>
            <a:r>
              <a:rPr lang="es-ES" dirty="0"/>
              <a:t> </a:t>
            </a:r>
            <a:r>
              <a:rPr lang="es-ES" dirty="0" err="1"/>
              <a:t>samples</a:t>
            </a:r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315391209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Agrupar 17"/>
          <p:cNvGrpSpPr/>
          <p:nvPr/>
        </p:nvGrpSpPr>
        <p:grpSpPr>
          <a:xfrm>
            <a:off x="5975350" y="3602435"/>
            <a:ext cx="3708400" cy="2514600"/>
            <a:chOff x="4451350" y="3602435"/>
            <a:chExt cx="3708400" cy="2514600"/>
          </a:xfrm>
        </p:grpSpPr>
        <p:pic>
          <p:nvPicPr>
            <p:cNvPr id="9" name="Imagen 8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451350" y="3602435"/>
              <a:ext cx="3708400" cy="2514600"/>
            </a:xfrm>
            <a:prstGeom prst="rect">
              <a:avLst/>
            </a:prstGeom>
          </p:spPr>
        </p:pic>
        <p:sp>
          <p:nvSpPr>
            <p:cNvPr id="6" name="Rectángulo 5"/>
            <p:cNvSpPr/>
            <p:nvPr/>
          </p:nvSpPr>
          <p:spPr>
            <a:xfrm>
              <a:off x="4451350" y="3924300"/>
              <a:ext cx="387350" cy="406400"/>
            </a:xfrm>
            <a:prstGeom prst="rect">
              <a:avLst/>
            </a:prstGeom>
            <a:solidFill>
              <a:srgbClr val="FFFFFF"/>
            </a:solidFill>
            <a:ln>
              <a:solidFill>
                <a:srgbClr val="FFFFFF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</p:grpSp>
      <p:pic>
        <p:nvPicPr>
          <p:cNvPr id="4" name="Imagen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89650" y="404108"/>
            <a:ext cx="3594100" cy="2514600"/>
          </a:xfrm>
          <a:prstGeom prst="rect">
            <a:avLst/>
          </a:prstGeom>
        </p:spPr>
      </p:pic>
      <p:pic>
        <p:nvPicPr>
          <p:cNvPr id="5" name="Imagen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078474" y="404108"/>
            <a:ext cx="3594100" cy="2514600"/>
          </a:xfrm>
          <a:prstGeom prst="rect">
            <a:avLst/>
          </a:prstGeom>
        </p:spPr>
      </p:pic>
      <p:sp>
        <p:nvSpPr>
          <p:cNvPr id="7" name="CuadroTexto 6"/>
          <p:cNvSpPr txBox="1"/>
          <p:nvPr/>
        </p:nvSpPr>
        <p:spPr>
          <a:xfrm>
            <a:off x="3137395" y="2918708"/>
            <a:ext cx="13216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 err="1"/>
              <a:t>Group</a:t>
            </a:r>
            <a:r>
              <a:rPr lang="es-ES" dirty="0"/>
              <a:t> A</a:t>
            </a:r>
          </a:p>
        </p:txBody>
      </p:sp>
      <p:sp>
        <p:nvSpPr>
          <p:cNvPr id="10" name="CuadroTexto 9"/>
          <p:cNvSpPr txBox="1"/>
          <p:nvPr/>
        </p:nvSpPr>
        <p:spPr>
          <a:xfrm>
            <a:off x="7494919" y="2990297"/>
            <a:ext cx="13216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 err="1"/>
              <a:t>Group</a:t>
            </a:r>
            <a:r>
              <a:rPr lang="es-ES" dirty="0"/>
              <a:t> A</a:t>
            </a:r>
          </a:p>
        </p:txBody>
      </p:sp>
      <p:sp>
        <p:nvSpPr>
          <p:cNvPr id="12" name="CuadroTexto 11"/>
          <p:cNvSpPr txBox="1"/>
          <p:nvPr/>
        </p:nvSpPr>
        <p:spPr>
          <a:xfrm>
            <a:off x="3798200" y="113077"/>
            <a:ext cx="13216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 err="1"/>
              <a:t>All</a:t>
            </a:r>
            <a:r>
              <a:rPr lang="es-ES" dirty="0"/>
              <a:t> </a:t>
            </a:r>
            <a:r>
              <a:rPr lang="es-ES" dirty="0" err="1"/>
              <a:t>samples</a:t>
            </a:r>
            <a:endParaRPr lang="es-ES" dirty="0"/>
          </a:p>
        </p:txBody>
      </p:sp>
      <p:sp>
        <p:nvSpPr>
          <p:cNvPr id="13" name="CuadroTexto 12"/>
          <p:cNvSpPr txBox="1"/>
          <p:nvPr/>
        </p:nvSpPr>
        <p:spPr>
          <a:xfrm>
            <a:off x="7991691" y="126467"/>
            <a:ext cx="13216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 err="1"/>
              <a:t>All</a:t>
            </a:r>
            <a:r>
              <a:rPr lang="es-ES" dirty="0"/>
              <a:t> </a:t>
            </a:r>
            <a:r>
              <a:rPr lang="es-ES" dirty="0" err="1"/>
              <a:t>samples</a:t>
            </a:r>
            <a:endParaRPr lang="es-ES" dirty="0"/>
          </a:p>
        </p:txBody>
      </p:sp>
      <p:sp>
        <p:nvSpPr>
          <p:cNvPr id="14" name="CuadroTexto 13"/>
          <p:cNvSpPr txBox="1"/>
          <p:nvPr/>
        </p:nvSpPr>
        <p:spPr>
          <a:xfrm>
            <a:off x="2499173" y="270359"/>
            <a:ext cx="5259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A)</a:t>
            </a:r>
          </a:p>
        </p:txBody>
      </p:sp>
      <p:sp>
        <p:nvSpPr>
          <p:cNvPr id="15" name="CuadroTexto 14"/>
          <p:cNvSpPr txBox="1"/>
          <p:nvPr/>
        </p:nvSpPr>
        <p:spPr>
          <a:xfrm>
            <a:off x="2628405" y="3233103"/>
            <a:ext cx="5259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B)</a:t>
            </a:r>
          </a:p>
        </p:txBody>
      </p:sp>
      <p:sp>
        <p:nvSpPr>
          <p:cNvPr id="16" name="CuadroTexto 15"/>
          <p:cNvSpPr txBox="1"/>
          <p:nvPr/>
        </p:nvSpPr>
        <p:spPr>
          <a:xfrm>
            <a:off x="6467753" y="184666"/>
            <a:ext cx="5259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C)</a:t>
            </a:r>
          </a:p>
        </p:txBody>
      </p:sp>
      <p:sp>
        <p:nvSpPr>
          <p:cNvPr id="17" name="CuadroTexto 16"/>
          <p:cNvSpPr txBox="1"/>
          <p:nvPr/>
        </p:nvSpPr>
        <p:spPr>
          <a:xfrm>
            <a:off x="6227256" y="3359629"/>
            <a:ext cx="5259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D)</a:t>
            </a:r>
          </a:p>
        </p:txBody>
      </p:sp>
      <p:pic>
        <p:nvPicPr>
          <p:cNvPr id="2" name="Imagen 1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152650" y="3602435"/>
            <a:ext cx="3708400" cy="2514600"/>
          </a:xfrm>
          <a:prstGeom prst="rect">
            <a:avLst/>
          </a:prstGeom>
        </p:spPr>
      </p:pic>
      <p:sp>
        <p:nvSpPr>
          <p:cNvPr id="3" name="CuadroTexto 2"/>
          <p:cNvSpPr txBox="1"/>
          <p:nvPr/>
        </p:nvSpPr>
        <p:spPr>
          <a:xfrm>
            <a:off x="8915400" y="3873501"/>
            <a:ext cx="11684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P </a:t>
            </a:r>
            <a:r>
              <a:rPr lang="es-ES" dirty="0" err="1"/>
              <a:t>value</a:t>
            </a:r>
            <a:r>
              <a:rPr lang="es-ES" dirty="0"/>
              <a:t> 0.018</a:t>
            </a:r>
          </a:p>
        </p:txBody>
      </p:sp>
    </p:spTree>
    <p:extLst>
      <p:ext uri="{BB962C8B-B14F-4D97-AF65-F5344CB8AC3E}">
        <p14:creationId xmlns:p14="http://schemas.microsoft.com/office/powerpoint/2010/main" val="138796514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5</Words>
  <Application>Microsoft Office PowerPoint</Application>
  <PresentationFormat>Panorámica</PresentationFormat>
  <Paragraphs>17</Paragraphs>
  <Slides>2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Tema de Office</vt:lpstr>
      <vt:lpstr>Presentación de PowerPoint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Epigenetica</dc:creator>
  <cp:lastModifiedBy>Epigenetica</cp:lastModifiedBy>
  <cp:revision>1</cp:revision>
  <dcterms:created xsi:type="dcterms:W3CDTF">2022-12-12T09:15:51Z</dcterms:created>
  <dcterms:modified xsi:type="dcterms:W3CDTF">2022-12-12T09:16:06Z</dcterms:modified>
</cp:coreProperties>
</file>